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>
        <p:scale>
          <a:sx n="120" d="100"/>
          <a:sy n="120" d="100"/>
        </p:scale>
        <p:origin x="19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902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290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246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001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231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741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9351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503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6213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928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032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A4CDD8-59E0-4B62-BAC3-C3D1C881749B}" type="datetimeFigureOut">
              <a:rPr lang="en-US" smtClean="0"/>
              <a:t>2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82CBA-8309-47CF-9D78-6BFD993B55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068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1" t="15106" r="10220" b="14816"/>
          <a:stretch/>
        </p:blipFill>
        <p:spPr>
          <a:xfrm rot="5400000">
            <a:off x="2065373" y="858583"/>
            <a:ext cx="3290777" cy="480591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44061" y="2766512"/>
            <a:ext cx="5765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OX1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5974261" y="2866293"/>
            <a:ext cx="5886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L1m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5974260" y="3074289"/>
            <a:ext cx="6662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TACO1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490714" y="3891224"/>
            <a:ext cx="9511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ITRAC12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5974260" y="2504408"/>
            <a:ext cx="6451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TP5B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773168" y="3221746"/>
            <a:ext cx="679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L10m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147901" y="38378"/>
            <a:ext cx="1930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 1: Exposure 20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1477925" y="1095154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1873192" y="1121451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093477" y="1095154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2488744" y="1121451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654080" y="1095155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3017451" y="1121452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3521967" y="1125306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3917234" y="1151603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4137519" y="1125306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4532786" y="1151603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4698122" y="1125307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5061493" y="1151604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3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67714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7901" y="38378"/>
            <a:ext cx="1813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 1: Exposure 3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69" t="14005" r="8375" b="14446"/>
          <a:stretch/>
        </p:blipFill>
        <p:spPr>
          <a:xfrm rot="5400000">
            <a:off x="1738610" y="-83209"/>
            <a:ext cx="4423142" cy="619508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47320" y="1873377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DHA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1244009" y="1019481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1740285" y="1045778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029683" y="1019481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2462164" y="1045778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712555" y="1019482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3187573" y="1045779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3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997264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7901" y="38378"/>
            <a:ext cx="1813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 1: Exposure 1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54" t="14083" r="9157" b="13127"/>
          <a:stretch/>
        </p:blipFill>
        <p:spPr>
          <a:xfrm rot="5400000">
            <a:off x="1531845" y="-314409"/>
            <a:ext cx="4556046" cy="675849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895517" y="4212539"/>
            <a:ext cx="680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OX6A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3758609" y="1003534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4260202" y="1029831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4512383" y="1003534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5024607" y="1029831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5344122" y="1003535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5829763" y="1029832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3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6115708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7" t="32899" r="2817" b="20877"/>
          <a:stretch/>
        </p:blipFill>
        <p:spPr>
          <a:xfrm rot="5400000">
            <a:off x="286613" y="1101403"/>
            <a:ext cx="4937700" cy="379539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057443" y="1524210"/>
            <a:ext cx="740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FG3L2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4136495" y="2314734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NDUFA9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4107971" y="2006957"/>
            <a:ext cx="686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uS14m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1520455" y="648587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1936986" y="674884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1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189167" y="648587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621651" y="674884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2</a:t>
            </a:r>
            <a:endParaRPr lang="en-US" sz="14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2914577" y="648588"/>
            <a:ext cx="968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Control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3315160" y="674885"/>
            <a:ext cx="7938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siMCU</a:t>
            </a:r>
            <a:r>
              <a:rPr lang="en-US" sz="1400" dirty="0" smtClean="0"/>
              <a:t> 3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256479" y="3342190"/>
            <a:ext cx="988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Histone H3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05691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Widescreen</PresentationFormat>
  <Paragraphs>4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DZ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umanska, Magdalena /DZNE</dc:creator>
  <cp:lastModifiedBy>Shumanska, Magdalena /DZNE</cp:lastModifiedBy>
  <cp:revision>2</cp:revision>
  <dcterms:created xsi:type="dcterms:W3CDTF">2024-02-19T13:51:20Z</dcterms:created>
  <dcterms:modified xsi:type="dcterms:W3CDTF">2024-02-19T14:00:44Z</dcterms:modified>
</cp:coreProperties>
</file>